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8"/>
  </p:notesMasterIdLst>
  <p:sldIdLst>
    <p:sldId id="280" r:id="rId2"/>
    <p:sldId id="278" r:id="rId3"/>
    <p:sldId id="279" r:id="rId4"/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  <p:sldId id="274" r:id="rId23"/>
    <p:sldId id="275" r:id="rId24"/>
    <p:sldId id="276" r:id="rId25"/>
    <p:sldId id="277" r:id="rId26"/>
    <p:sldId id="281" r:id="rId27"/>
    <p:sldId id="282" r:id="rId28"/>
    <p:sldId id="283" r:id="rId29"/>
    <p:sldId id="284" r:id="rId30"/>
    <p:sldId id="285" r:id="rId31"/>
    <p:sldId id="286" r:id="rId32"/>
    <p:sldId id="287" r:id="rId33"/>
    <p:sldId id="288" r:id="rId34"/>
    <p:sldId id="289" r:id="rId35"/>
    <p:sldId id="290" r:id="rId36"/>
    <p:sldId id="291" r:id="rId37"/>
    <p:sldId id="293" r:id="rId38"/>
    <p:sldId id="294" r:id="rId39"/>
    <p:sldId id="297" r:id="rId40"/>
    <p:sldId id="299" r:id="rId41"/>
    <p:sldId id="300" r:id="rId42"/>
    <p:sldId id="303" r:id="rId43"/>
    <p:sldId id="308" r:id="rId44"/>
    <p:sldId id="309" r:id="rId45"/>
    <p:sldId id="310" r:id="rId46"/>
    <p:sldId id="311" r:id="rId47"/>
    <p:sldId id="312" r:id="rId48"/>
    <p:sldId id="313" r:id="rId49"/>
    <p:sldId id="314" r:id="rId50"/>
    <p:sldId id="315" r:id="rId51"/>
    <p:sldId id="316" r:id="rId52"/>
    <p:sldId id="296" r:id="rId53"/>
    <p:sldId id="305" r:id="rId54"/>
    <p:sldId id="304" r:id="rId55"/>
    <p:sldId id="306" r:id="rId56"/>
    <p:sldId id="307" r:id="rId5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2814" y="-9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61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4.emf"/></Relationships>
</file>

<file path=ppt/drawings/_rels/vmlDrawing10.vml.rels><?xml version="1.0" encoding="UTF-8" standalone="yes"?>
<Relationships xmlns="http://schemas.openxmlformats.org/package/2006/relationships"><Relationship Id="rId1" Type="http://schemas.openxmlformats.org/officeDocument/2006/relationships/image" Target="../media/image44.emf"/></Relationships>
</file>

<file path=ppt/drawings/_rels/vmlDrawing1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5.emf"/></Relationships>
</file>

<file path=ppt/drawings/_rels/vmlDrawing12.vml.rels><?xml version="1.0" encoding="UTF-8" standalone="yes"?>
<Relationships xmlns="http://schemas.openxmlformats.org/package/2006/relationships"><Relationship Id="rId1" Type="http://schemas.openxmlformats.org/officeDocument/2006/relationships/image" Target="../media/image46.emf"/></Relationships>
</file>

<file path=ppt/drawings/_rels/vmlDrawing13.vml.rels><?xml version="1.0" encoding="UTF-8" standalone="yes"?>
<Relationships xmlns="http://schemas.openxmlformats.org/package/2006/relationships"><Relationship Id="rId1" Type="http://schemas.openxmlformats.org/officeDocument/2006/relationships/image" Target="../media/image47.emf"/></Relationships>
</file>

<file path=ppt/drawings/_rels/vmlDrawing1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8.emf"/></Relationships>
</file>

<file path=ppt/drawings/_rels/vmlDrawing15.vml.rels><?xml version="1.0" encoding="UTF-8" standalone="yes"?>
<Relationships xmlns="http://schemas.openxmlformats.org/package/2006/relationships"><Relationship Id="rId1" Type="http://schemas.openxmlformats.org/officeDocument/2006/relationships/image" Target="../media/image49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5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6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37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38.emf"/></Relationships>
</file>

<file path=ppt/drawings/_rels/vmlDrawing6.vml.rels><?xml version="1.0" encoding="UTF-8" standalone="yes"?>
<Relationships xmlns="http://schemas.openxmlformats.org/package/2006/relationships"><Relationship Id="rId2" Type="http://schemas.openxmlformats.org/officeDocument/2006/relationships/image" Target="../media/image40.emf"/><Relationship Id="rId1" Type="http://schemas.openxmlformats.org/officeDocument/2006/relationships/image" Target="../media/image39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41.e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42.e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4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C6B0EC-3CB1-4304-95E7-645F6D7C23E0}" type="datetimeFigureOut">
              <a:rPr lang="en-US" smtClean="0"/>
              <a:t>9/14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E83B3FA-D364-408A-9BBE-61BFA73C95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6234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E83B3FA-D364-408A-9BBE-61BFA73C9598}" type="slidenum">
              <a:rPr lang="en-US" smtClean="0"/>
              <a:t>5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2695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E0044-175F-4C4D-B129-4B731E98D4AA}" type="datetimeFigureOut">
              <a:rPr lang="en-US" smtClean="0"/>
              <a:t>9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1E0EC-AFC4-4969-A68F-9BA6CD8453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730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E0044-175F-4C4D-B129-4B731E98D4AA}" type="datetimeFigureOut">
              <a:rPr lang="en-US" smtClean="0"/>
              <a:t>9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1E0EC-AFC4-4969-A68F-9BA6CD8453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0921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E0044-175F-4C4D-B129-4B731E98D4AA}" type="datetimeFigureOut">
              <a:rPr lang="en-US" smtClean="0"/>
              <a:t>9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1E0EC-AFC4-4969-A68F-9BA6CD8453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064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E0044-175F-4C4D-B129-4B731E98D4AA}" type="datetimeFigureOut">
              <a:rPr lang="en-US" smtClean="0"/>
              <a:t>9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1E0EC-AFC4-4969-A68F-9BA6CD8453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648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E0044-175F-4C4D-B129-4B731E98D4AA}" type="datetimeFigureOut">
              <a:rPr lang="en-US" smtClean="0"/>
              <a:t>9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1E0EC-AFC4-4969-A68F-9BA6CD8453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900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E0044-175F-4C4D-B129-4B731E98D4AA}" type="datetimeFigureOut">
              <a:rPr lang="en-US" smtClean="0"/>
              <a:t>9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1E0EC-AFC4-4969-A68F-9BA6CD8453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016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E0044-175F-4C4D-B129-4B731E98D4AA}" type="datetimeFigureOut">
              <a:rPr lang="en-US" smtClean="0"/>
              <a:t>9/1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1E0EC-AFC4-4969-A68F-9BA6CD8453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444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E0044-175F-4C4D-B129-4B731E98D4AA}" type="datetimeFigureOut">
              <a:rPr lang="en-US" smtClean="0"/>
              <a:t>9/1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1E0EC-AFC4-4969-A68F-9BA6CD8453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0570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E0044-175F-4C4D-B129-4B731E98D4AA}" type="datetimeFigureOut">
              <a:rPr lang="en-US" smtClean="0"/>
              <a:t>9/1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1E0EC-AFC4-4969-A68F-9BA6CD8453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259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E0044-175F-4C4D-B129-4B731E98D4AA}" type="datetimeFigureOut">
              <a:rPr lang="en-US" smtClean="0"/>
              <a:t>9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1E0EC-AFC4-4969-A68F-9BA6CD8453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55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E0044-175F-4C4D-B129-4B731E98D4AA}" type="datetimeFigureOut">
              <a:rPr lang="en-US" smtClean="0"/>
              <a:t>9/1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1E0EC-AFC4-4969-A68F-9BA6CD8453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5035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AE0044-175F-4C4D-B129-4B731E98D4AA}" type="datetimeFigureOut">
              <a:rPr lang="en-US" smtClean="0"/>
              <a:t>9/1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C1E0EC-AFC4-4969-A68F-9BA6CD8453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6709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34.emf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35.emf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6.emf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37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4" Type="http://schemas.openxmlformats.org/officeDocument/2006/relationships/image" Target="../media/image38.emf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40.e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39.emf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4" Type="http://schemas.openxmlformats.org/officeDocument/2006/relationships/image" Target="../media/image41.emf"/></Relationships>
</file>

<file path=ppt/slides/_rels/slide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4" Type="http://schemas.openxmlformats.org/officeDocument/2006/relationships/image" Target="../media/image42.emf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4" Type="http://schemas.openxmlformats.org/officeDocument/2006/relationships/image" Target="../media/image43.emf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Relationship Id="rId4" Type="http://schemas.openxmlformats.org/officeDocument/2006/relationships/image" Target="../media/image44.emf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1.vml"/><Relationship Id="rId4" Type="http://schemas.openxmlformats.org/officeDocument/2006/relationships/image" Target="../media/image45.emf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2.vml"/><Relationship Id="rId4" Type="http://schemas.openxmlformats.org/officeDocument/2006/relationships/image" Target="../media/image46.emf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3.vml"/><Relationship Id="rId4" Type="http://schemas.openxmlformats.org/officeDocument/2006/relationships/image" Target="../media/image47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4.vml"/><Relationship Id="rId4" Type="http://schemas.openxmlformats.org/officeDocument/2006/relationships/image" Target="../media/image48.emf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5.vml"/><Relationship Id="rId4" Type="http://schemas.openxmlformats.org/officeDocument/2006/relationships/image" Target="../media/image49.emf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7.xml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/Relationships>
</file>

<file path=ppt/slides/_rels/slide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7.xml"/></Relationships>
</file>

<file path=ppt/slides/_rels/slide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7.png"/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7.xml"/></Relationships>
</file>

<file path=ppt/slides/_rels/slide5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9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2" descr="C:\Users\jklug\Documents\Data\Electrophysiology\Raw Data\Images\20140912\M1 10X.TIF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1786684" y="1828765"/>
            <a:ext cx="5757150" cy="43013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057400" y="228600"/>
            <a:ext cx="518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</a:t>
            </a:r>
            <a:r>
              <a:rPr lang="en-US" dirty="0" err="1" smtClean="0"/>
              <a:t>mCherry</a:t>
            </a:r>
            <a:r>
              <a:rPr lang="en-US" dirty="0" smtClean="0"/>
              <a:t> Positive Neurons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33400" y="19812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2/3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33400" y="33528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A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33400" y="4120817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5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3383674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792983"/>
            <a:ext cx="9115168" cy="50650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514600" y="110335"/>
            <a:ext cx="4343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Baseline IV -250pA to +400pA +50pA step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43600" y="3136284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30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7313190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318650"/>
            <a:ext cx="9144000" cy="5539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514600" y="110335"/>
            <a:ext cx="4343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Baseline IV -250pA to +400pA +50pA step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096000" y="3136284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35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0232477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2438401"/>
            <a:ext cx="9107301" cy="441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514600" y="110335"/>
            <a:ext cx="4343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Baseline IV -250pA to +400pA +50pA step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267450" y="3733800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40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0783835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28800" y="2743200"/>
            <a:ext cx="5486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10µM </a:t>
            </a:r>
            <a:r>
              <a:rPr lang="en-US" dirty="0" err="1" smtClean="0"/>
              <a:t>Quinpirole</a:t>
            </a:r>
            <a:r>
              <a:rPr lang="en-US" dirty="0" smtClean="0"/>
              <a:t> (D2 agonist) </a:t>
            </a:r>
          </a:p>
          <a:p>
            <a:pPr algn="ctr"/>
            <a:r>
              <a:rPr lang="en-US" dirty="0" smtClean="0"/>
              <a:t>Wash in 8mi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964047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2746" y="2295593"/>
            <a:ext cx="9166746" cy="45624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828800" y="110335"/>
            <a:ext cx="601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10uM </a:t>
            </a:r>
            <a:r>
              <a:rPr lang="en-US" dirty="0" err="1" smtClean="0"/>
              <a:t>Quinpirole</a:t>
            </a:r>
            <a:r>
              <a:rPr lang="en-US" dirty="0" smtClean="0"/>
              <a:t> IV -250pA to +400pA +50pA step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529005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070381"/>
            <a:ext cx="9144000" cy="47876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828800" y="110335"/>
            <a:ext cx="601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10uM </a:t>
            </a:r>
            <a:r>
              <a:rPr lang="en-US" dirty="0" err="1" smtClean="0"/>
              <a:t>Quinpirole</a:t>
            </a:r>
            <a:r>
              <a:rPr lang="en-US" dirty="0" smtClean="0"/>
              <a:t> IV -250pA to +400pA +50pA steps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5562600" y="3117163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5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731624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350652"/>
            <a:ext cx="9143999" cy="45016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828800" y="110335"/>
            <a:ext cx="601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10uM </a:t>
            </a:r>
            <a:r>
              <a:rPr lang="en-US" dirty="0" err="1" smtClean="0"/>
              <a:t>Quinpirole</a:t>
            </a:r>
            <a:r>
              <a:rPr lang="en-US" dirty="0" smtClean="0"/>
              <a:t> IV -250pA to +400pA +50pA steps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715000" y="3657600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10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336917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6158" y="1951954"/>
            <a:ext cx="9170158" cy="49003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828800" y="110335"/>
            <a:ext cx="601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10uM </a:t>
            </a:r>
            <a:r>
              <a:rPr lang="en-US" dirty="0" err="1" smtClean="0"/>
              <a:t>Quinpirole</a:t>
            </a:r>
            <a:r>
              <a:rPr lang="en-US" dirty="0" smtClean="0"/>
              <a:t> IV -250pA to +400pA +50pA steps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096000" y="3641834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15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326480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049859"/>
            <a:ext cx="9144000" cy="48388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828800" y="110335"/>
            <a:ext cx="601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10uM </a:t>
            </a:r>
            <a:r>
              <a:rPr lang="en-US" dirty="0" err="1" smtClean="0"/>
              <a:t>Quinpirole</a:t>
            </a:r>
            <a:r>
              <a:rPr lang="en-US" dirty="0" smtClean="0"/>
              <a:t> IV -250pA to +400pA +50pA steps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096000" y="3641834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20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326480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48" y="2692422"/>
            <a:ext cx="9130352" cy="41598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828800" y="110335"/>
            <a:ext cx="601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10uM </a:t>
            </a:r>
            <a:r>
              <a:rPr lang="en-US" dirty="0" err="1" smtClean="0"/>
              <a:t>Quinpirole</a:t>
            </a:r>
            <a:r>
              <a:rPr lang="en-US" dirty="0" smtClean="0"/>
              <a:t> IV -250pA to +400pA +50pA steps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096000" y="3641834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25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32648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6" name="Picture 2" descr="C:\Users\jklug\Documents\Data\Electrophysiology\Raw Data\Images\20140912\M1 DIC Channel layer 5b patched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111955" y="2636082"/>
            <a:ext cx="4576836" cy="34194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507" name="Picture 3" descr="C:\Users\jklug\Documents\Data\Electrophysiology\Raw Data\Images\20140912\M1 mCherry Channel layer 5b patched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4679119" y="2636082"/>
            <a:ext cx="4576836" cy="34194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2057400" y="228600"/>
            <a:ext cx="518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</a:t>
            </a:r>
            <a:r>
              <a:rPr lang="en-US" dirty="0" err="1" smtClean="0"/>
              <a:t>mCherry</a:t>
            </a:r>
            <a:r>
              <a:rPr lang="en-US" dirty="0" smtClean="0"/>
              <a:t> Positive Neurons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618291" y="858293"/>
            <a:ext cx="2059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atched M1 Cell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1983618" y="1512332"/>
            <a:ext cx="609600" cy="381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DIC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6210300" y="1524000"/>
            <a:ext cx="2057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mCherry</a:t>
            </a:r>
            <a:r>
              <a:rPr lang="en-US" dirty="0" smtClean="0"/>
              <a:t> Positiv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557427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412660"/>
            <a:ext cx="9143999" cy="44453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828800" y="110335"/>
            <a:ext cx="601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10uM </a:t>
            </a:r>
            <a:r>
              <a:rPr lang="en-US" dirty="0" err="1" smtClean="0"/>
              <a:t>Quinpirole</a:t>
            </a:r>
            <a:r>
              <a:rPr lang="en-US" dirty="0" smtClean="0"/>
              <a:t> IV -250pA to +400pA +50pA step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096000" y="3641834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30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23465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1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766" y="2670185"/>
            <a:ext cx="9128234" cy="41799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828800" y="110335"/>
            <a:ext cx="601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10uM </a:t>
            </a:r>
            <a:r>
              <a:rPr lang="en-US" dirty="0" err="1" smtClean="0"/>
              <a:t>Quinpirole</a:t>
            </a:r>
            <a:r>
              <a:rPr lang="en-US" dirty="0" smtClean="0"/>
              <a:t> IV -250pA to +400pA +50pA steps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6096000" y="3641834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35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356324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976415"/>
            <a:ext cx="9144000" cy="48815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828800" y="110335"/>
            <a:ext cx="601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10uM </a:t>
            </a:r>
            <a:r>
              <a:rPr lang="en-US" dirty="0" err="1" smtClean="0"/>
              <a:t>Quinpirole</a:t>
            </a:r>
            <a:r>
              <a:rPr lang="en-US" dirty="0" smtClean="0"/>
              <a:t> IV -250pA to +400pA +50pA steps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477000" y="3673365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40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7968891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082357"/>
            <a:ext cx="9165021" cy="47756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828800" y="110335"/>
            <a:ext cx="601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10uM </a:t>
            </a:r>
            <a:r>
              <a:rPr lang="en-US" dirty="0" err="1" smtClean="0"/>
              <a:t>Quinpirole</a:t>
            </a:r>
            <a:r>
              <a:rPr lang="en-US" dirty="0" smtClean="0"/>
              <a:t> IV -250pA to +400pA +50pA steps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477000" y="3673365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45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7968891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287522"/>
            <a:ext cx="9144000" cy="45888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828800" y="110335"/>
            <a:ext cx="6019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10uM </a:t>
            </a:r>
            <a:r>
              <a:rPr lang="en-US" dirty="0" err="1" smtClean="0"/>
              <a:t>Quinpirole</a:t>
            </a:r>
            <a:r>
              <a:rPr lang="en-US" dirty="0" smtClean="0"/>
              <a:t> IV -250pA to +400pA +50pA step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477000" y="3673365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50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6216933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38600" y="2578837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Wash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9421102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57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0" y="2533981"/>
            <a:ext cx="9124950" cy="43240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981200" y="110335"/>
            <a:ext cx="5486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Wash 20min IV -250pA to +400pA +50pA step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27659527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348177"/>
            <a:ext cx="9143999" cy="45098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981200" y="110335"/>
            <a:ext cx="5486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Wash 20min IV -250pA to +400pA +50pA step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508531" y="3673365"/>
            <a:ext cx="11811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100pA</a:t>
            </a:r>
          </a:p>
          <a:p>
            <a:r>
              <a:rPr lang="en-US" dirty="0" smtClean="0"/>
              <a:t>+50pA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5547672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133601"/>
            <a:ext cx="9127471" cy="472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981200" y="110335"/>
            <a:ext cx="5486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Wash 20min IV -250pA to +400pA +50pA step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508531" y="3673365"/>
            <a:ext cx="11811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150pA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92400157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3" y="1889194"/>
            <a:ext cx="9115567" cy="49688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981200" y="110335"/>
            <a:ext cx="5486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Wash 20min IV -250pA to +400pA +50pA step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508531" y="3673365"/>
            <a:ext cx="11811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200pA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872854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30" name="Picture 2" descr="C:\Users\jklug\Documents\Data\Electrophysiology\Raw Data\Images\20140912\M1 cell patched electrode placement.TIF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1219199" y="1066799"/>
            <a:ext cx="6629401" cy="4953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371600" y="228598"/>
            <a:ext cx="6324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Electrode Placeme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58525228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074984"/>
            <a:ext cx="9144000" cy="47830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981200" y="110335"/>
            <a:ext cx="5486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Wash 20min IV -250pA to +400pA +50pA step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508531" y="3673365"/>
            <a:ext cx="11811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250pA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67869175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2042573"/>
            <a:ext cx="9143999" cy="48154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981200" y="110335"/>
            <a:ext cx="5486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Wash 20min IV -250pA to +400pA +50pA steps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508531" y="3673365"/>
            <a:ext cx="11811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300pA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7887659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1976414"/>
            <a:ext cx="9143999" cy="48815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981200" y="110335"/>
            <a:ext cx="5486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Wash 20min IV -250pA to +400pA +50pA steps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508531" y="3673365"/>
            <a:ext cx="11811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350pA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7887659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60" y="1384986"/>
            <a:ext cx="9126940" cy="54741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981200" y="110335"/>
            <a:ext cx="5486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Wash 20min IV -250pA to +400pA +50pA steps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508531" y="3673365"/>
            <a:ext cx="11811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400pA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7887659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7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5" y="2424546"/>
            <a:ext cx="9144000" cy="44334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981200" y="110335"/>
            <a:ext cx="5486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Wash 20min IV -250pA to +400pA +50pA steps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508531" y="3673365"/>
            <a:ext cx="11811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450pA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87887659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975995899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1018279"/>
              </p:ext>
            </p:extLst>
          </p:nvPr>
        </p:nvGraphicFramePr>
        <p:xfrm>
          <a:off x="3352800" y="1676400"/>
          <a:ext cx="2971800" cy="43226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820" name="Prism 6" r:id="rId3" imgW="2286862" imgH="3328183" progId="Prism6.Document">
                  <p:embed/>
                </p:oleObj>
              </mc:Choice>
              <mc:Fallback>
                <p:oleObj name="Prism 6" r:id="rId3" imgW="2286862" imgH="3328183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352800" y="1676400"/>
                        <a:ext cx="2971800" cy="43226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918103240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39288" y="4724400"/>
            <a:ext cx="157051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Membrane inward rectification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828800" y="304800"/>
            <a:ext cx="3429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IV Steady State</a:t>
            </a:r>
            <a:endParaRPr lang="en-US" dirty="0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8067356"/>
              </p:ext>
            </p:extLst>
          </p:nvPr>
        </p:nvGraphicFramePr>
        <p:xfrm>
          <a:off x="1284288" y="223838"/>
          <a:ext cx="6577012" cy="6411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843" name="Prism 6" r:id="rId3" imgW="6577159" imgH="6412543" progId="Prism6.Document">
                  <p:embed/>
                </p:oleObj>
              </mc:Choice>
              <mc:Fallback>
                <p:oleObj name="Prism 6" r:id="rId3" imgW="6577159" imgH="6412543" progId="Prism6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84288" y="223838"/>
                        <a:ext cx="6577012" cy="64119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87370811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828800" y="304800"/>
            <a:ext cx="3429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IV </a:t>
            </a:r>
            <a:r>
              <a:rPr lang="en-US" dirty="0" err="1" smtClean="0"/>
              <a:t>Ih</a:t>
            </a:r>
            <a:r>
              <a:rPr lang="en-US" dirty="0" smtClean="0"/>
              <a:t> current</a:t>
            </a:r>
            <a:endParaRPr lang="en-US" dirty="0"/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3499711"/>
              </p:ext>
            </p:extLst>
          </p:nvPr>
        </p:nvGraphicFramePr>
        <p:xfrm>
          <a:off x="1284288" y="223838"/>
          <a:ext cx="6577012" cy="6411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5863" name="Prism 6" r:id="rId3" imgW="6577159" imgH="6412543" progId="Prism6.Document">
                  <p:embed/>
                </p:oleObj>
              </mc:Choice>
              <mc:Fallback>
                <p:oleObj name="Prism 6" r:id="rId3" imgW="6577159" imgH="6412543" progId="Prism6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84288" y="223838"/>
                        <a:ext cx="6577012" cy="64119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52944110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6713582"/>
              </p:ext>
            </p:extLst>
          </p:nvPr>
        </p:nvGraphicFramePr>
        <p:xfrm>
          <a:off x="2571750" y="1397000"/>
          <a:ext cx="3998913" cy="406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931" name="Prism 6" r:id="rId3" imgW="6778114" imgH="6888306" progId="Prism6.Document">
                  <p:embed/>
                </p:oleObj>
              </mc:Choice>
              <mc:Fallback>
                <p:oleObj name="Prism 6" r:id="rId3" imgW="6778114" imgH="688830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71750" y="1397000"/>
                        <a:ext cx="3998913" cy="406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743200" y="457200"/>
            <a:ext cx="381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 smtClean="0"/>
              <a:t>Ih</a:t>
            </a:r>
            <a:r>
              <a:rPr lang="en-US" dirty="0" smtClean="0"/>
              <a:t> Current Amplitud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95743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757104"/>
            <a:ext cx="9144000" cy="60885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514600" y="110335"/>
            <a:ext cx="4343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Baseline IV -250pA to +400pA +50pA steps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990600" y="6023237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Ih</a:t>
            </a:r>
            <a:r>
              <a:rPr lang="en-US" dirty="0" smtClean="0"/>
              <a:t> Curre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1334687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4237192"/>
              </p:ext>
            </p:extLst>
          </p:nvPr>
        </p:nvGraphicFramePr>
        <p:xfrm>
          <a:off x="3414713" y="1841500"/>
          <a:ext cx="2314575" cy="3173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77" name="Prism 6" r:id="rId3" imgW="2314232" imgH="3172957" progId="Prism6.Document">
                  <p:embed/>
                </p:oleObj>
              </mc:Choice>
              <mc:Fallback>
                <p:oleObj name="Prism 6" r:id="rId3" imgW="2314232" imgH="317295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14713" y="1841500"/>
                        <a:ext cx="2314575" cy="3173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33963868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8327066"/>
              </p:ext>
            </p:extLst>
          </p:nvPr>
        </p:nvGraphicFramePr>
        <p:xfrm>
          <a:off x="1143000" y="2209800"/>
          <a:ext cx="2314575" cy="3173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037" name="Prism 6" r:id="rId3" imgW="2314232" imgH="3172957" progId="Prism6.Document">
                  <p:embed/>
                </p:oleObj>
              </mc:Choice>
              <mc:Fallback>
                <p:oleObj name="Prism 6" r:id="rId3" imgW="2314232" imgH="317295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43000" y="2209800"/>
                        <a:ext cx="2314575" cy="3173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4651895"/>
              </p:ext>
            </p:extLst>
          </p:nvPr>
        </p:nvGraphicFramePr>
        <p:xfrm>
          <a:off x="3886200" y="2133600"/>
          <a:ext cx="2278063" cy="3173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038" name="Prism 6" r:id="rId5" imgW="2277858" imgH="3172957" progId="Prism6.Document">
                  <p:embed/>
                </p:oleObj>
              </mc:Choice>
              <mc:Fallback>
                <p:oleObj name="Prism 6" r:id="rId5" imgW="2277858" imgH="3172957" progId="Prism6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86200" y="2133600"/>
                        <a:ext cx="2278063" cy="31734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427311088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1586604"/>
              </p:ext>
            </p:extLst>
          </p:nvPr>
        </p:nvGraphicFramePr>
        <p:xfrm>
          <a:off x="1371600" y="-129528"/>
          <a:ext cx="6553200" cy="69553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4047" name="Prism 6" r:id="rId3" imgW="6485684" imgH="6883984" progId="Prism6.Document">
                  <p:embed/>
                </p:oleObj>
              </mc:Choice>
              <mc:Fallback>
                <p:oleObj name="Prism 6" r:id="rId3" imgW="6485684" imgH="688398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71600" y="-129528"/>
                        <a:ext cx="6553200" cy="69553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99830103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23337796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6573706"/>
              </p:ext>
            </p:extLst>
          </p:nvPr>
        </p:nvGraphicFramePr>
        <p:xfrm>
          <a:off x="2659063" y="1397000"/>
          <a:ext cx="3824287" cy="406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9154" name="Prism 6" r:id="rId3" imgW="6476321" imgH="6883984" progId="Prism6.Document">
                  <p:embed/>
                </p:oleObj>
              </mc:Choice>
              <mc:Fallback>
                <p:oleObj name="Prism 6" r:id="rId3" imgW="6476321" imgH="688398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59063" y="1397000"/>
                        <a:ext cx="3824287" cy="406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143000" y="424934"/>
            <a:ext cx="655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+50pA 1</a:t>
            </a:r>
            <a:r>
              <a:rPr lang="en-US" baseline="30000" dirty="0" smtClean="0"/>
              <a:t>st</a:t>
            </a:r>
            <a:r>
              <a:rPr lang="en-US" dirty="0" smtClean="0"/>
              <a:t> Swee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9301867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1928134"/>
              </p:ext>
            </p:extLst>
          </p:nvPr>
        </p:nvGraphicFramePr>
        <p:xfrm>
          <a:off x="2659063" y="1397000"/>
          <a:ext cx="3824287" cy="406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0178" name="Prism 6" r:id="rId3" imgW="6476321" imgH="6883984" progId="Prism6.Document">
                  <p:embed/>
                </p:oleObj>
              </mc:Choice>
              <mc:Fallback>
                <p:oleObj name="Prism 6" r:id="rId3" imgW="6476321" imgH="688398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59063" y="1397000"/>
                        <a:ext cx="3824287" cy="406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323833" y="639591"/>
            <a:ext cx="655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+100pA 2nd Swee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7897998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4659889"/>
              </p:ext>
            </p:extLst>
          </p:nvPr>
        </p:nvGraphicFramePr>
        <p:xfrm>
          <a:off x="2659063" y="1397000"/>
          <a:ext cx="3824287" cy="406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02" name="Prism 6" r:id="rId3" imgW="6476321" imgH="6883984" progId="Prism6.Document">
                  <p:embed/>
                </p:oleObj>
              </mc:Choice>
              <mc:Fallback>
                <p:oleObj name="Prism 6" r:id="rId3" imgW="6476321" imgH="688398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59063" y="1397000"/>
                        <a:ext cx="3824287" cy="406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323833" y="639591"/>
            <a:ext cx="655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+150pA 3</a:t>
            </a:r>
            <a:r>
              <a:rPr lang="en-US" baseline="30000" dirty="0" smtClean="0"/>
              <a:t>rd</a:t>
            </a:r>
            <a:r>
              <a:rPr lang="en-US" dirty="0" smtClean="0"/>
              <a:t> Swee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0291533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0641505"/>
              </p:ext>
            </p:extLst>
          </p:nvPr>
        </p:nvGraphicFramePr>
        <p:xfrm>
          <a:off x="2681288" y="1397000"/>
          <a:ext cx="3781425" cy="406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26" name="Prism 6" r:id="rId3" imgW="6403213" imgH="6883984" progId="Prism6.Document">
                  <p:embed/>
                </p:oleObj>
              </mc:Choice>
              <mc:Fallback>
                <p:oleObj name="Prism 6" r:id="rId3" imgW="6403213" imgH="688398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81288" y="1397000"/>
                        <a:ext cx="3781425" cy="406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323833" y="639591"/>
            <a:ext cx="655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+200pA 4th Swee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7915370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8569176"/>
              </p:ext>
            </p:extLst>
          </p:nvPr>
        </p:nvGraphicFramePr>
        <p:xfrm>
          <a:off x="2681288" y="1397000"/>
          <a:ext cx="3781425" cy="406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250" name="Prism 6" r:id="rId3" imgW="6403213" imgH="6883984" progId="Prism6.Document">
                  <p:embed/>
                </p:oleObj>
              </mc:Choice>
              <mc:Fallback>
                <p:oleObj name="Prism 6" r:id="rId3" imgW="6403213" imgH="688398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81288" y="1397000"/>
                        <a:ext cx="3781425" cy="406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323833" y="639591"/>
            <a:ext cx="655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+250pA </a:t>
            </a:r>
            <a:r>
              <a:rPr lang="en-US" dirty="0"/>
              <a:t>5</a:t>
            </a:r>
            <a:r>
              <a:rPr lang="en-US" dirty="0" smtClean="0"/>
              <a:t>th Swee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44159791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2201189"/>
              </p:ext>
            </p:extLst>
          </p:nvPr>
        </p:nvGraphicFramePr>
        <p:xfrm>
          <a:off x="2681288" y="1397000"/>
          <a:ext cx="3781425" cy="406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274" name="Prism 6" r:id="rId3" imgW="6403213" imgH="6883984" progId="Prism6.Document">
                  <p:embed/>
                </p:oleObj>
              </mc:Choice>
              <mc:Fallback>
                <p:oleObj name="Prism 6" r:id="rId3" imgW="6403213" imgH="688398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81288" y="1397000"/>
                        <a:ext cx="3781425" cy="406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323833" y="639591"/>
            <a:ext cx="655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+300pA 6th Swee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304876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243625"/>
            <a:ext cx="9144000" cy="5614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990600" y="6023237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/>
              <a:t>Ih</a:t>
            </a:r>
            <a:r>
              <a:rPr lang="en-US" dirty="0" smtClean="0"/>
              <a:t> Current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990600" y="3163330"/>
            <a:ext cx="1600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Intrinsic Burst Type Cell (IB)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514600" y="110335"/>
            <a:ext cx="4343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Baseline IV -250pA to +400pA +50pA steps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562600" y="3117163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5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3556501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9730063"/>
              </p:ext>
            </p:extLst>
          </p:nvPr>
        </p:nvGraphicFramePr>
        <p:xfrm>
          <a:off x="2681288" y="1397000"/>
          <a:ext cx="3781425" cy="406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5298" name="Prism 6" r:id="rId3" imgW="6403213" imgH="6883984" progId="Prism6.Document">
                  <p:embed/>
                </p:oleObj>
              </mc:Choice>
              <mc:Fallback>
                <p:oleObj name="Prism 6" r:id="rId3" imgW="6403213" imgH="688398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81288" y="1397000"/>
                        <a:ext cx="3781425" cy="406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323833" y="639591"/>
            <a:ext cx="655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+350pA </a:t>
            </a:r>
            <a:r>
              <a:rPr lang="en-US" dirty="0"/>
              <a:t>7</a:t>
            </a:r>
            <a:r>
              <a:rPr lang="en-US" dirty="0" smtClean="0"/>
              <a:t>th Swee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5694388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766015"/>
              </p:ext>
            </p:extLst>
          </p:nvPr>
        </p:nvGraphicFramePr>
        <p:xfrm>
          <a:off x="2687638" y="1397000"/>
          <a:ext cx="3768725" cy="406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6322" name="Prism 6" r:id="rId3" imgW="6476321" imgH="6984467" progId="Prism6.Document">
                  <p:embed/>
                </p:oleObj>
              </mc:Choice>
              <mc:Fallback>
                <p:oleObj name="Prism 6" r:id="rId3" imgW="6476321" imgH="698446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687638" y="1397000"/>
                        <a:ext cx="3768725" cy="406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51504177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371600" y="152400"/>
            <a:ext cx="662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 smtClean="0"/>
              <a:t>Opto</a:t>
            </a:r>
            <a:r>
              <a:rPr lang="en-US" dirty="0" smtClean="0"/>
              <a:t> 5Hz 2.5ms pulse width</a:t>
            </a:r>
            <a:endParaRPr lang="en-US" dirty="0"/>
          </a:p>
        </p:txBody>
      </p:sp>
      <p:pic>
        <p:nvPicPr>
          <p:cNvPr id="37893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6276" y="1073151"/>
            <a:ext cx="9151883" cy="42320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894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5602023"/>
            <a:ext cx="9151883" cy="10929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023660146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08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2032" y="1752600"/>
            <a:ext cx="9144000" cy="31167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6083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2032" y="5410200"/>
            <a:ext cx="9131968" cy="76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371600" y="152400"/>
            <a:ext cx="662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 smtClean="0"/>
              <a:t>Opto</a:t>
            </a:r>
            <a:r>
              <a:rPr lang="en-US" dirty="0" smtClean="0"/>
              <a:t> 5Hz 10ms pulse width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79756625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425039" y="341623"/>
            <a:ext cx="662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 smtClean="0"/>
              <a:t>Opto</a:t>
            </a:r>
            <a:r>
              <a:rPr lang="en-US" dirty="0" smtClean="0"/>
              <a:t> 20Hz 2.5ms pulse width</a:t>
            </a:r>
            <a:endParaRPr lang="en-US" dirty="0"/>
          </a:p>
        </p:txBody>
      </p:sp>
      <p:pic>
        <p:nvPicPr>
          <p:cNvPr id="45060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057400"/>
            <a:ext cx="9123947" cy="31099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5061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486400"/>
            <a:ext cx="9111915" cy="914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279503312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25039" y="341623"/>
            <a:ext cx="662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 smtClean="0"/>
              <a:t>Opto</a:t>
            </a:r>
            <a:r>
              <a:rPr lang="en-US" dirty="0" smtClean="0"/>
              <a:t> 20Hz 10ms pulse width</a:t>
            </a:r>
            <a:endParaRPr lang="en-US" dirty="0"/>
          </a:p>
        </p:txBody>
      </p:sp>
      <p:pic>
        <p:nvPicPr>
          <p:cNvPr id="47108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63" y="2209800"/>
            <a:ext cx="9119937" cy="3108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7109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5603277"/>
            <a:ext cx="9143999" cy="3861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097291455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13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828800"/>
            <a:ext cx="9144000" cy="3124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8131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410200"/>
            <a:ext cx="9117724" cy="838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425039" y="341623"/>
            <a:ext cx="6629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 smtClean="0"/>
              <a:t>Opto</a:t>
            </a:r>
            <a:r>
              <a:rPr lang="en-US" dirty="0" smtClean="0"/>
              <a:t> 500ms Consta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85271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8238" y="1803362"/>
            <a:ext cx="9152238" cy="5054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514600" y="110335"/>
            <a:ext cx="4343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Baseline IV -250pA to +400pA +50pA step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43600" y="3136284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10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00202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96" y="2133857"/>
            <a:ext cx="9057503" cy="47241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514600" y="110335"/>
            <a:ext cx="4343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Baseline IV -250pA to +400pA +50pA step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43600" y="3136284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15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545374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16" y="1713781"/>
            <a:ext cx="9129583" cy="51359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514600" y="110335"/>
            <a:ext cx="4343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Baseline IV -250pA to +400pA +50pA step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43600" y="3136284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20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52999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818146"/>
            <a:ext cx="9143999" cy="50398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514600" y="110335"/>
            <a:ext cx="4343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D1CRE M1 layer 5 cell </a:t>
            </a:r>
          </a:p>
          <a:p>
            <a:pPr algn="ctr"/>
            <a:r>
              <a:rPr lang="en-US" dirty="0" smtClean="0"/>
              <a:t>Baseline IV -250pA to +400pA +50pA step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43600" y="3136284"/>
            <a:ext cx="11811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+250p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38767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</TotalTime>
  <Words>615</Words>
  <Application>Microsoft Office PowerPoint</Application>
  <PresentationFormat>On-screen Show (4:3)</PresentationFormat>
  <Paragraphs>117</Paragraphs>
  <Slides>56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6</vt:i4>
      </vt:variant>
    </vt:vector>
  </HeadingPairs>
  <TitlesOfParts>
    <vt:vector size="58" baseType="lpstr">
      <vt:lpstr>Office Theme</vt:lpstr>
      <vt:lpstr>GraphPad Prism 6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klug</dc:creator>
  <cp:lastModifiedBy>jklug</cp:lastModifiedBy>
  <cp:revision>32</cp:revision>
  <dcterms:created xsi:type="dcterms:W3CDTF">2014-09-14T22:46:20Z</dcterms:created>
  <dcterms:modified xsi:type="dcterms:W3CDTF">2014-09-15T04:55:31Z</dcterms:modified>
</cp:coreProperties>
</file>